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1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-1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1662215029081096"/>
          <c:y val="3.5980986194451389E-3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2:$B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I$2:$I$5</c:f>
              <c:numCache>
                <c:formatCode>General</c:formatCode>
                <c:ptCount val="4"/>
                <c:pt idx="0">
                  <c:v>1</c:v>
                </c:pt>
                <c:pt idx="1">
                  <c:v>0.6771642345993778</c:v>
                </c:pt>
                <c:pt idx="2">
                  <c:v>0.58097860822413627</c:v>
                </c:pt>
                <c:pt idx="3">
                  <c:v>0.232207960739162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29974656"/>
        <c:axId val="229975216"/>
      </c:barChart>
      <c:catAx>
        <c:axId val="229974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9975216"/>
        <c:crosses val="autoZero"/>
        <c:auto val="1"/>
        <c:lblAlgn val="ctr"/>
        <c:lblOffset val="100"/>
        <c:noMultiLvlLbl val="0"/>
      </c:catAx>
      <c:valAx>
        <c:axId val="229975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99746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53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9645546048871109"/>
          <c:y val="4.1262480275776323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15:$B$18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L$15:$L$18</c:f>
              <c:numCache>
                <c:formatCode>General</c:formatCode>
                <c:ptCount val="4"/>
                <c:pt idx="0">
                  <c:v>1</c:v>
                </c:pt>
                <c:pt idx="1">
                  <c:v>0.69864700130363289</c:v>
                </c:pt>
                <c:pt idx="2">
                  <c:v>0.7735687581739964</c:v>
                </c:pt>
                <c:pt idx="3">
                  <c:v>0.460055913903402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37073888"/>
        <c:axId val="237074448"/>
      </c:barChart>
      <c:catAx>
        <c:axId val="237073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4448"/>
        <c:crosses val="autoZero"/>
        <c:auto val="1"/>
        <c:lblAlgn val="ctr"/>
        <c:lblOffset val="100"/>
        <c:noMultiLvlLbl val="0"/>
      </c:catAx>
      <c:valAx>
        <c:axId val="237074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38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3461447199245112"/>
          <c:y val="2.8724729447540898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15:$B$18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M$15:$M$18</c:f>
              <c:numCache>
                <c:formatCode>General</c:formatCode>
                <c:ptCount val="4"/>
                <c:pt idx="0">
                  <c:v>1</c:v>
                </c:pt>
                <c:pt idx="1">
                  <c:v>1.2130339837535731</c:v>
                </c:pt>
                <c:pt idx="2">
                  <c:v>0.90172771767196058</c:v>
                </c:pt>
                <c:pt idx="3">
                  <c:v>1.30999700302640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37076688"/>
        <c:axId val="237077248"/>
      </c:barChart>
      <c:catAx>
        <c:axId val="237076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7248"/>
        <c:crosses val="autoZero"/>
        <c:auto val="1"/>
        <c:lblAlgn val="ctr"/>
        <c:lblOffset val="100"/>
        <c:noMultiLvlLbl val="0"/>
      </c:catAx>
      <c:valAx>
        <c:axId val="237077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66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CL-2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7507978357507099"/>
          <c:y val="5.4105349932741083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15:$B$18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N$15:$N$18</c:f>
              <c:numCache>
                <c:formatCode>General</c:formatCode>
                <c:ptCount val="4"/>
                <c:pt idx="0">
                  <c:v>1</c:v>
                </c:pt>
                <c:pt idx="1">
                  <c:v>1.0997750463667619</c:v>
                </c:pt>
                <c:pt idx="2">
                  <c:v>1.0215403754148049</c:v>
                </c:pt>
                <c:pt idx="3">
                  <c:v>1.6928888867407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37079488"/>
        <c:axId val="237080048"/>
      </c:barChart>
      <c:catAx>
        <c:axId val="237079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80048"/>
        <c:crosses val="autoZero"/>
        <c:auto val="1"/>
        <c:lblAlgn val="ctr"/>
        <c:lblOffset val="100"/>
        <c:noMultiLvlLbl val="0"/>
      </c:catAx>
      <c:valAx>
        <c:axId val="237080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94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ac</a:t>
            </a:r>
          </a:p>
        </c:rich>
      </c:tx>
      <c:layout>
        <c:manualLayout>
          <c:xMode val="edge"/>
          <c:yMode val="edge"/>
          <c:x val="0.40123355475262079"/>
          <c:y val="5.0752647154364942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2:$B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J$2:$J$5</c:f>
              <c:numCache>
                <c:formatCode>General</c:formatCode>
                <c:ptCount val="4"/>
                <c:pt idx="0">
                  <c:v>1</c:v>
                </c:pt>
                <c:pt idx="1">
                  <c:v>0.93621118111880275</c:v>
                </c:pt>
                <c:pt idx="2">
                  <c:v>0.33509608287082132</c:v>
                </c:pt>
                <c:pt idx="3">
                  <c:v>1.10849233585056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29977456"/>
        <c:axId val="185353072"/>
      </c:barChart>
      <c:catAx>
        <c:axId val="229977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353072"/>
        <c:crosses val="autoZero"/>
        <c:auto val="1"/>
        <c:lblAlgn val="ctr"/>
        <c:lblOffset val="100"/>
        <c:noMultiLvlLbl val="0"/>
      </c:catAx>
      <c:valAx>
        <c:axId val="185353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99774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in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7872227943816"/>
          <c:y val="5.8644047971960541E-3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2:$B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K$2:$K$5</c:f>
              <c:numCache>
                <c:formatCode>General</c:formatCode>
                <c:ptCount val="4"/>
                <c:pt idx="0">
                  <c:v>1</c:v>
                </c:pt>
                <c:pt idx="1">
                  <c:v>1.2897862977757055</c:v>
                </c:pt>
                <c:pt idx="2">
                  <c:v>1.1489674900621933</c:v>
                </c:pt>
                <c:pt idx="3">
                  <c:v>0.393651983789296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5355312"/>
        <c:axId val="185355872"/>
      </c:barChart>
      <c:catAx>
        <c:axId val="185355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355872"/>
        <c:crosses val="autoZero"/>
        <c:auto val="1"/>
        <c:lblAlgn val="ctr"/>
        <c:lblOffset val="100"/>
        <c:noMultiLvlLbl val="0"/>
      </c:catAx>
      <c:valAx>
        <c:axId val="1853558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3553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53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6748277889065804"/>
          <c:y val="3.1534652307620349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2:$B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L$2:$L$5</c:f>
              <c:numCache>
                <c:formatCode>General</c:formatCode>
                <c:ptCount val="4"/>
                <c:pt idx="0">
                  <c:v>1</c:v>
                </c:pt>
                <c:pt idx="1">
                  <c:v>0.76544912927295039</c:v>
                </c:pt>
                <c:pt idx="2">
                  <c:v>0.66666580197099223</c:v>
                </c:pt>
                <c:pt idx="3">
                  <c:v>0.632713527108495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5358112"/>
        <c:axId val="185358672"/>
      </c:barChart>
      <c:catAx>
        <c:axId val="185358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358672"/>
        <c:crosses val="autoZero"/>
        <c:auto val="1"/>
        <c:lblAlgn val="ctr"/>
        <c:lblOffset val="100"/>
        <c:noMultiLvlLbl val="0"/>
      </c:catAx>
      <c:valAx>
        <c:axId val="185358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53581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118327541653503"/>
          <c:y val="3.9163516934249437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2:$B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M$2:$M$5</c:f>
              <c:numCache>
                <c:formatCode>General</c:formatCode>
                <c:ptCount val="4"/>
                <c:pt idx="0">
                  <c:v>1</c:v>
                </c:pt>
                <c:pt idx="1">
                  <c:v>0.66172195976933168</c:v>
                </c:pt>
                <c:pt idx="2">
                  <c:v>0.3444135464723948</c:v>
                </c:pt>
                <c:pt idx="3">
                  <c:v>1.52094871056900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560912"/>
        <c:axId val="183561472"/>
      </c:barChart>
      <c:catAx>
        <c:axId val="183560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561472"/>
        <c:crosses val="autoZero"/>
        <c:auto val="1"/>
        <c:lblAlgn val="ctr"/>
        <c:lblOffset val="100"/>
        <c:noMultiLvlLbl val="0"/>
      </c:catAx>
      <c:valAx>
        <c:axId val="1835614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5609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CL-2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0429545277134066"/>
          <c:y val="0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2:$B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N$2:$N$5</c:f>
              <c:numCache>
                <c:formatCode>General</c:formatCode>
                <c:ptCount val="4"/>
                <c:pt idx="0">
                  <c:v>1</c:v>
                </c:pt>
                <c:pt idx="1">
                  <c:v>1.0334781768779868</c:v>
                </c:pt>
                <c:pt idx="2">
                  <c:v>0.54082040875466841</c:v>
                </c:pt>
                <c:pt idx="3">
                  <c:v>0.900310075307106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563712"/>
        <c:axId val="183564272"/>
      </c:barChart>
      <c:catAx>
        <c:axId val="183563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564272"/>
        <c:crosses val="autoZero"/>
        <c:auto val="1"/>
        <c:lblAlgn val="ctr"/>
        <c:lblOffset val="100"/>
        <c:noMultiLvlLbl val="0"/>
      </c:catAx>
      <c:valAx>
        <c:axId val="183564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5637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-1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3682383593290555"/>
          <c:y val="2.7668950807546652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15:$B$18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I$15:$I$18</c:f>
              <c:numCache>
                <c:formatCode>General</c:formatCode>
                <c:ptCount val="4"/>
                <c:pt idx="0">
                  <c:v>1</c:v>
                </c:pt>
                <c:pt idx="1">
                  <c:v>1.2181862382680786</c:v>
                </c:pt>
                <c:pt idx="2">
                  <c:v>1.0591881543696939</c:v>
                </c:pt>
                <c:pt idx="3">
                  <c:v>0.381282118050245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566512"/>
        <c:axId val="183567072"/>
      </c:barChart>
      <c:catAx>
        <c:axId val="183566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567072"/>
        <c:crosses val="autoZero"/>
        <c:auto val="1"/>
        <c:lblAlgn val="ctr"/>
        <c:lblOffset val="100"/>
        <c:noMultiLvlLbl val="0"/>
      </c:catAx>
      <c:valAx>
        <c:axId val="183567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5665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ac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8172248534055023"/>
          <c:y val="4.032123643325327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15:$B$18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J$15:$J$18</c:f>
              <c:numCache>
                <c:formatCode>General</c:formatCode>
                <c:ptCount val="4"/>
                <c:pt idx="0">
                  <c:v>1</c:v>
                </c:pt>
                <c:pt idx="1">
                  <c:v>1.578158725424601</c:v>
                </c:pt>
                <c:pt idx="2">
                  <c:v>0.75296321854460935</c:v>
                </c:pt>
                <c:pt idx="3">
                  <c:v>1.2945222823642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37067728"/>
        <c:axId val="237068288"/>
      </c:barChart>
      <c:catAx>
        <c:axId val="237067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68288"/>
        <c:crosses val="autoZero"/>
        <c:auto val="1"/>
        <c:lblAlgn val="ctr"/>
        <c:lblOffset val="100"/>
        <c:noMultiLvlLbl val="0"/>
      </c:catAx>
      <c:valAx>
        <c:axId val="237068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677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in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381449230781146"/>
          <c:y val="4.7831443928527236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15:$B$18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K$15:$K$18</c:f>
              <c:numCache>
                <c:formatCode>General</c:formatCode>
                <c:ptCount val="4"/>
                <c:pt idx="0">
                  <c:v>1</c:v>
                </c:pt>
                <c:pt idx="1">
                  <c:v>0.99031845989580569</c:v>
                </c:pt>
                <c:pt idx="2">
                  <c:v>0.58871989981759643</c:v>
                </c:pt>
                <c:pt idx="3">
                  <c:v>7.45156342650791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37070528"/>
        <c:axId val="237071088"/>
      </c:barChart>
      <c:catAx>
        <c:axId val="237070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1088"/>
        <c:crosses val="autoZero"/>
        <c:auto val="1"/>
        <c:lblAlgn val="ctr"/>
        <c:lblOffset val="100"/>
        <c:noMultiLvlLbl val="0"/>
      </c:catAx>
      <c:valAx>
        <c:axId val="237071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70705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136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2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0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6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04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21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85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0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93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/>
          <p:cNvGrpSpPr/>
          <p:nvPr/>
        </p:nvGrpSpPr>
        <p:grpSpPr>
          <a:xfrm>
            <a:off x="184454" y="239287"/>
            <a:ext cx="11655207" cy="5641093"/>
            <a:chOff x="184454" y="239287"/>
            <a:chExt cx="11655207" cy="5641093"/>
          </a:xfrm>
        </p:grpSpPr>
        <p:sp>
          <p:nvSpPr>
            <p:cNvPr id="2" name="TextBox 1"/>
            <p:cNvSpPr txBox="1"/>
            <p:nvPr/>
          </p:nvSpPr>
          <p:spPr>
            <a:xfrm>
              <a:off x="184454" y="239287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352839" y="861692"/>
              <a:ext cx="1876128" cy="1945036"/>
              <a:chOff x="982142" y="939749"/>
              <a:chExt cx="2015441" cy="1945036"/>
            </a:xfrm>
          </p:grpSpPr>
          <p:graphicFrame>
            <p:nvGraphicFramePr>
              <p:cNvPr id="3" name="图表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30503037"/>
                  </p:ext>
                </p:extLst>
              </p:nvPr>
            </p:nvGraphicFramePr>
            <p:xfrm>
              <a:off x="1169607" y="976277"/>
              <a:ext cx="1827976" cy="190850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TextBox 3"/>
              <p:cNvSpPr txBox="1"/>
              <p:nvPr/>
            </p:nvSpPr>
            <p:spPr>
              <a:xfrm rot="5400000" flipV="1">
                <a:off x="494499" y="1427392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2166769" y="793434"/>
              <a:ext cx="1883712" cy="2013294"/>
              <a:chOff x="3618073" y="1124800"/>
              <a:chExt cx="1957704" cy="2013294"/>
            </a:xfrm>
          </p:grpSpPr>
          <p:graphicFrame>
            <p:nvGraphicFramePr>
              <p:cNvPr id="6" name="图表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08211989"/>
                  </p:ext>
                </p:extLst>
              </p:nvPr>
            </p:nvGraphicFramePr>
            <p:xfrm>
              <a:off x="3802803" y="1124800"/>
              <a:ext cx="1772974" cy="201329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 rot="5400000" flipV="1">
                <a:off x="3130430" y="1702544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4104481" y="860728"/>
              <a:ext cx="1967131" cy="1983492"/>
              <a:chOff x="5801705" y="1218053"/>
              <a:chExt cx="1974133" cy="1983492"/>
            </a:xfrm>
          </p:grpSpPr>
          <p:graphicFrame>
            <p:nvGraphicFramePr>
              <p:cNvPr id="9" name="图表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83342477"/>
                  </p:ext>
                </p:extLst>
              </p:nvPr>
            </p:nvGraphicFramePr>
            <p:xfrm>
              <a:off x="5983849" y="1218053"/>
              <a:ext cx="1791989" cy="198349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 rot="5400000" flipV="1">
                <a:off x="5314062" y="1750120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6050934" y="827877"/>
              <a:ext cx="1952353" cy="2052504"/>
              <a:chOff x="8067538" y="1188083"/>
              <a:chExt cx="2007050" cy="1838647"/>
            </a:xfrm>
          </p:grpSpPr>
          <p:graphicFrame>
            <p:nvGraphicFramePr>
              <p:cNvPr id="12" name="图表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28714008"/>
                  </p:ext>
                </p:extLst>
              </p:nvPr>
            </p:nvGraphicFramePr>
            <p:xfrm>
              <a:off x="8273288" y="1188083"/>
              <a:ext cx="1801300" cy="183864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3" name="TextBox 12"/>
              <p:cNvSpPr txBox="1"/>
              <p:nvPr/>
            </p:nvSpPr>
            <p:spPr>
              <a:xfrm rot="5400000" flipV="1">
                <a:off x="7672179" y="1726079"/>
                <a:ext cx="1043838" cy="253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7964316" y="876745"/>
              <a:ext cx="1914064" cy="2018690"/>
              <a:chOff x="4804161" y="3403218"/>
              <a:chExt cx="1981650" cy="1881510"/>
            </a:xfrm>
          </p:grpSpPr>
          <p:graphicFrame>
            <p:nvGraphicFramePr>
              <p:cNvPr id="15" name="图表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23500205"/>
                  </p:ext>
                </p:extLst>
              </p:nvPr>
            </p:nvGraphicFramePr>
            <p:xfrm>
              <a:off x="4963670" y="3403218"/>
              <a:ext cx="1822141" cy="188151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6" name="TextBox 15"/>
              <p:cNvSpPr txBox="1"/>
              <p:nvPr/>
            </p:nvSpPr>
            <p:spPr>
              <a:xfrm rot="5400000" flipV="1">
                <a:off x="4316518" y="3890862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9911344" y="987103"/>
              <a:ext cx="1871375" cy="1908332"/>
              <a:chOff x="8070147" y="3387335"/>
              <a:chExt cx="1871375" cy="1746818"/>
            </a:xfrm>
          </p:grpSpPr>
          <p:graphicFrame>
            <p:nvGraphicFramePr>
              <p:cNvPr id="18" name="图表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56621513"/>
                  </p:ext>
                </p:extLst>
              </p:nvPr>
            </p:nvGraphicFramePr>
            <p:xfrm>
              <a:off x="8224916" y="3387335"/>
              <a:ext cx="1716606" cy="174681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9" name="TextBox 18"/>
              <p:cNvSpPr txBox="1"/>
              <p:nvPr/>
            </p:nvSpPr>
            <p:spPr>
              <a:xfrm rot="5400000" flipV="1">
                <a:off x="7666421" y="3831913"/>
                <a:ext cx="10536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cxnSp>
          <p:nvCxnSpPr>
            <p:cNvPr id="22" name="Straight Connector 21"/>
            <p:cNvCxnSpPr/>
            <p:nvPr/>
          </p:nvCxnSpPr>
          <p:spPr>
            <a:xfrm flipV="1">
              <a:off x="722752" y="2902329"/>
              <a:ext cx="10656364" cy="3437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5579169" y="305165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-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84454" y="58372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352794" y="3457138"/>
              <a:ext cx="1846030" cy="1987047"/>
              <a:chOff x="597670" y="3686681"/>
              <a:chExt cx="1846030" cy="1835993"/>
            </a:xfrm>
          </p:grpSpPr>
          <p:graphicFrame>
            <p:nvGraphicFramePr>
              <p:cNvPr id="25" name="图表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37972574"/>
                  </p:ext>
                </p:extLst>
              </p:nvPr>
            </p:nvGraphicFramePr>
            <p:xfrm>
              <a:off x="736496" y="3686681"/>
              <a:ext cx="1707204" cy="18359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26" name="TextBox 25"/>
              <p:cNvSpPr txBox="1"/>
              <p:nvPr/>
            </p:nvSpPr>
            <p:spPr>
              <a:xfrm rot="5400000" flipV="1">
                <a:off x="157073" y="4189938"/>
                <a:ext cx="11274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2112169" y="3457138"/>
              <a:ext cx="1868558" cy="1989389"/>
              <a:chOff x="2694502" y="3624067"/>
              <a:chExt cx="1868558" cy="1889823"/>
            </a:xfrm>
          </p:grpSpPr>
          <p:graphicFrame>
            <p:nvGraphicFramePr>
              <p:cNvPr id="28" name="图表 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63507505"/>
                  </p:ext>
                </p:extLst>
              </p:nvPr>
            </p:nvGraphicFramePr>
            <p:xfrm>
              <a:off x="2867824" y="3624067"/>
              <a:ext cx="1695236" cy="18898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29" name="TextBox 28"/>
              <p:cNvSpPr txBox="1"/>
              <p:nvPr/>
            </p:nvSpPr>
            <p:spPr>
              <a:xfrm rot="5400000" flipV="1">
                <a:off x="2253905" y="4176441"/>
                <a:ext cx="11274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4067394" y="3443602"/>
              <a:ext cx="1971827" cy="1971712"/>
              <a:chOff x="4862878" y="3816572"/>
              <a:chExt cx="1971827" cy="1858610"/>
            </a:xfrm>
          </p:grpSpPr>
          <p:graphicFrame>
            <p:nvGraphicFramePr>
              <p:cNvPr id="31" name="图表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41602585"/>
                  </p:ext>
                </p:extLst>
              </p:nvPr>
            </p:nvGraphicFramePr>
            <p:xfrm>
              <a:off x="5027222" y="3816572"/>
              <a:ext cx="1807483" cy="185861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32" name="TextBox 31"/>
              <p:cNvSpPr txBox="1"/>
              <p:nvPr/>
            </p:nvSpPr>
            <p:spPr>
              <a:xfrm rot="5400000" flipV="1">
                <a:off x="4422281" y="4346150"/>
                <a:ext cx="11274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6071612" y="3427740"/>
              <a:ext cx="1948974" cy="1965875"/>
              <a:chOff x="6376879" y="3556704"/>
              <a:chExt cx="1948974" cy="1846714"/>
            </a:xfrm>
          </p:grpSpPr>
          <p:graphicFrame>
            <p:nvGraphicFramePr>
              <p:cNvPr id="34" name="图表 1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96736432"/>
                  </p:ext>
                </p:extLst>
              </p:nvPr>
            </p:nvGraphicFramePr>
            <p:xfrm>
              <a:off x="6534365" y="3556704"/>
              <a:ext cx="1791488" cy="184671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sp>
            <p:nvSpPr>
              <p:cNvPr id="35" name="TextBox 34"/>
              <p:cNvSpPr txBox="1"/>
              <p:nvPr/>
            </p:nvSpPr>
            <p:spPr>
              <a:xfrm rot="5400000" flipV="1">
                <a:off x="5936282" y="4089299"/>
                <a:ext cx="11274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7956641" y="3474772"/>
              <a:ext cx="1935301" cy="1871810"/>
              <a:chOff x="8333656" y="3416968"/>
              <a:chExt cx="1935301" cy="1768511"/>
            </a:xfrm>
          </p:grpSpPr>
          <p:graphicFrame>
            <p:nvGraphicFramePr>
              <p:cNvPr id="37" name="图表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48721238"/>
                  </p:ext>
                </p:extLst>
              </p:nvPr>
            </p:nvGraphicFramePr>
            <p:xfrm>
              <a:off x="8456767" y="3416968"/>
              <a:ext cx="1812190" cy="176851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38" name="TextBox 37"/>
              <p:cNvSpPr txBox="1"/>
              <p:nvPr/>
            </p:nvSpPr>
            <p:spPr>
              <a:xfrm rot="5400000" flipV="1">
                <a:off x="7893059" y="3898545"/>
                <a:ext cx="11274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42" name="Group 41"/>
            <p:cNvGrpSpPr/>
            <p:nvPr/>
          </p:nvGrpSpPr>
          <p:grpSpPr>
            <a:xfrm>
              <a:off x="9943002" y="3328653"/>
              <a:ext cx="1896659" cy="2006303"/>
              <a:chOff x="9943002" y="3457138"/>
              <a:chExt cx="1896659" cy="1877818"/>
            </a:xfrm>
          </p:grpSpPr>
          <p:graphicFrame>
            <p:nvGraphicFramePr>
              <p:cNvPr id="40" name="图表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08231111"/>
                  </p:ext>
                </p:extLst>
              </p:nvPr>
            </p:nvGraphicFramePr>
            <p:xfrm>
              <a:off x="10066113" y="3457138"/>
              <a:ext cx="1773548" cy="187781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41" name="TextBox 40"/>
              <p:cNvSpPr txBox="1"/>
              <p:nvPr/>
            </p:nvSpPr>
            <p:spPr>
              <a:xfrm rot="5400000" flipV="1">
                <a:off x="9502405" y="4036929"/>
                <a:ext cx="11274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43" name="TextBox 42"/>
            <p:cNvSpPr txBox="1"/>
            <p:nvPr/>
          </p:nvSpPr>
          <p:spPr>
            <a:xfrm>
              <a:off x="189276" y="336868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 flipV="1">
              <a:off x="866541" y="5469918"/>
              <a:ext cx="10656364" cy="3437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5537171" y="5603381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.1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3660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42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Ping</dc:creator>
  <cp:lastModifiedBy>Fan,Ping</cp:lastModifiedBy>
  <cp:revision>29</cp:revision>
  <dcterms:created xsi:type="dcterms:W3CDTF">2018-03-12T14:59:56Z</dcterms:created>
  <dcterms:modified xsi:type="dcterms:W3CDTF">2018-03-13T17:08:09Z</dcterms:modified>
</cp:coreProperties>
</file>